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1" r:id="rId2"/>
    <p:sldId id="263" r:id="rId3"/>
    <p:sldId id="264" r:id="rId4"/>
  </p:sldIdLst>
  <p:sldSz cx="12192000" cy="6858000"/>
  <p:notesSz cx="6858000" cy="9144000"/>
  <p:custDataLst>
    <p:tags r:id="rId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75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20AC1B-6F75-4140-B6EF-179161A31991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49170B-97E9-43C2-9C59-22AEBC09D1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造影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488789" y="283291"/>
            <a:ext cx="5190203" cy="5190203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195705" y="5728335"/>
            <a:ext cx="11457940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37415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ideo 1</a:t>
            </a:r>
            <a:r>
              <a:rPr lang="en-US" altLang="zh-CN" dirty="0">
                <a:solidFill>
                  <a:srgbClr val="37415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zh-CN" altLang="en-US" dirty="0">
                <a:solidFill>
                  <a:srgbClr val="37415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0" i="0" dirty="0">
                <a:solidFill>
                  <a:srgbClr val="37415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aortic angiography  indicating the presence of PDA with left-to-right shunting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457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封堵中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681466" y="429442"/>
            <a:ext cx="5302763" cy="5302763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835741" y="5908790"/>
            <a:ext cx="10304207" cy="6451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37415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ideo 2:  the occlusion process of the PDA, showing the successful deployment of the occlusion device resulting in the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cclusion</a:t>
            </a:r>
            <a:r>
              <a:rPr lang="en-US" altLang="zh-CN" b="0" i="0" dirty="0">
                <a:solidFill>
                  <a:srgbClr val="37415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the ductus arteriosu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032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封堵后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487710" y="301624"/>
            <a:ext cx="5342091" cy="5342091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209368" y="5910045"/>
            <a:ext cx="10304206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37415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ideo 3: After completion of the occlusion procedure, the occlusion device maintains an optimal morphology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765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</p:childTnLst>
        </p:cTn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jEyZWEzYmU3MjRkZjcwMjNhMmYyYzk1NzIyZmM1MjA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60</Words>
  <Application>Microsoft Office PowerPoint</Application>
  <PresentationFormat>宽屏</PresentationFormat>
  <Paragraphs>3</Paragraphs>
  <Slides>3</Slides>
  <Notes>0</Notes>
  <HiddenSlides>0</HiddenSlides>
  <MMClips>3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元国 陈元国</dc:creator>
  <cp:lastModifiedBy>元国 陈元国</cp:lastModifiedBy>
  <cp:revision>20</cp:revision>
  <dcterms:created xsi:type="dcterms:W3CDTF">2023-08-25T07:30:00Z</dcterms:created>
  <dcterms:modified xsi:type="dcterms:W3CDTF">2024-01-26T09:13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4F6A5706FE54376A4DD2EFA48E1754E_12</vt:lpwstr>
  </property>
  <property fmtid="{D5CDD505-2E9C-101B-9397-08002B2CF9AE}" pid="3" name="KSOProductBuildVer">
    <vt:lpwstr>2052-12.1.0.16250</vt:lpwstr>
  </property>
</Properties>
</file>